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8" r:id="rId2"/>
  </p:sldIdLst>
  <p:sldSz cx="7559675" cy="106918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18" userDrawn="1">
          <p15:clr>
            <a:srgbClr val="A4A3A4"/>
          </p15:clr>
        </p15:guide>
        <p15:guide id="2" pos="81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7" autoAdjust="0"/>
    <p:restoredTop sz="94660"/>
  </p:normalViewPr>
  <p:slideViewPr>
    <p:cSldViewPr snapToGrid="0" showGuides="1">
      <p:cViewPr varScale="1">
        <p:scale>
          <a:sx n="53" d="100"/>
          <a:sy n="53" d="100"/>
        </p:scale>
        <p:origin x="2539" y="36"/>
      </p:cViewPr>
      <p:guideLst>
        <p:guide orient="horz" pos="3118"/>
        <p:guide pos="81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F5D80-EDF2-471C-979E-CCF277EB0D28}" type="datetimeFigureOut">
              <a:rPr lang="en-GB" smtClean="0"/>
              <a:t>16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27E12C-3B81-49AE-9FDC-7D57D6A9A13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305067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F5D80-EDF2-471C-979E-CCF277EB0D28}" type="datetimeFigureOut">
              <a:rPr lang="en-GB" smtClean="0"/>
              <a:t>16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27E12C-3B81-49AE-9FDC-7D57D6A9A13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993157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F5D80-EDF2-471C-979E-CCF277EB0D28}" type="datetimeFigureOut">
              <a:rPr lang="en-GB" smtClean="0"/>
              <a:t>16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27E12C-3B81-49AE-9FDC-7D57D6A9A13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91868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F5D80-EDF2-471C-979E-CCF277EB0D28}" type="datetimeFigureOut">
              <a:rPr lang="en-GB" smtClean="0"/>
              <a:t>16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27E12C-3B81-49AE-9FDC-7D57D6A9A13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15634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F5D80-EDF2-471C-979E-CCF277EB0D28}" type="datetimeFigureOut">
              <a:rPr lang="en-GB" smtClean="0"/>
              <a:t>16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27E12C-3B81-49AE-9FDC-7D57D6A9A13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558865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F5D80-EDF2-471C-979E-CCF277EB0D28}" type="datetimeFigureOut">
              <a:rPr lang="en-GB" smtClean="0"/>
              <a:t>16/0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27E12C-3B81-49AE-9FDC-7D57D6A9A13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819297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F5D80-EDF2-471C-979E-CCF277EB0D28}" type="datetimeFigureOut">
              <a:rPr lang="en-GB" smtClean="0"/>
              <a:t>16/01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27E12C-3B81-49AE-9FDC-7D57D6A9A13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022750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F5D80-EDF2-471C-979E-CCF277EB0D28}" type="datetimeFigureOut">
              <a:rPr lang="en-GB" smtClean="0"/>
              <a:t>16/01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27E12C-3B81-49AE-9FDC-7D57D6A9A13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949422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F5D80-EDF2-471C-979E-CCF277EB0D28}" type="datetimeFigureOut">
              <a:rPr lang="en-GB" smtClean="0"/>
              <a:t>16/01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27E12C-3B81-49AE-9FDC-7D57D6A9A13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278230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F5D80-EDF2-471C-979E-CCF277EB0D28}" type="datetimeFigureOut">
              <a:rPr lang="en-GB" smtClean="0"/>
              <a:t>16/0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27E12C-3B81-49AE-9FDC-7D57D6A9A13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769661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F5D80-EDF2-471C-979E-CCF277EB0D28}" type="datetimeFigureOut">
              <a:rPr lang="en-GB" smtClean="0"/>
              <a:t>16/0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27E12C-3B81-49AE-9FDC-7D57D6A9A13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70202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3F5D80-EDF2-471C-979E-CCF277EB0D28}" type="datetimeFigureOut">
              <a:rPr lang="en-GB" smtClean="0"/>
              <a:t>16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27E12C-3B81-49AE-9FDC-7D57D6A9A13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113451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id="{65818224-6309-4EAE-BB9D-1C7D844CF124}"/>
              </a:ext>
            </a:extLst>
          </p:cNvPr>
          <p:cNvSpPr txBox="1"/>
          <p:nvPr/>
        </p:nvSpPr>
        <p:spPr>
          <a:xfrm>
            <a:off x="518400" y="475200"/>
            <a:ext cx="621360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2: Figure S2.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upal size. Abdominal length [AL, mm, mean ± SD] of female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e. </a:t>
            </a:r>
            <a:r>
              <a:rPr lang="en-US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bopictus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x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ipiens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pure and mixed cohorts in dependence of temperature and larval food regime. Line - linear regression. Dotted lines - 95% confidence interval.</a:t>
            </a:r>
            <a:endParaRPr lang="en-GB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Grafik 2">
            <a:extLst>
              <a:ext uri="{FF2B5EF4-FFF2-40B4-BE49-F238E27FC236}">
                <a16:creationId xmlns:a16="http://schemas.microsoft.com/office/drawing/2014/main" id="{50F9A846-9D36-47CA-A174-57FD53AACB5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1087" y="2697331"/>
            <a:ext cx="6268225" cy="66507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746311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57</Words>
  <Application>Microsoft Office PowerPoint</Application>
  <PresentationFormat>Benutzerdefiniert</PresentationFormat>
  <Paragraphs>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Ruth</dc:creator>
  <cp:lastModifiedBy>Ruth</cp:lastModifiedBy>
  <cp:revision>2</cp:revision>
  <dcterms:created xsi:type="dcterms:W3CDTF">2018-01-16T15:29:56Z</dcterms:created>
  <dcterms:modified xsi:type="dcterms:W3CDTF">2018-01-16T15:37:49Z</dcterms:modified>
</cp:coreProperties>
</file>